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MX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72" y="11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ocuments\UNAM-IBT\Maestria\Proyecto%20PTS\Resultados\Datos%20crudos%20articulo%200.4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scatterChart>
        <c:scatterStyle val="smoothMarker"/>
        <c:ser>
          <c:idx val="0"/>
          <c:order val="0"/>
          <c:tx>
            <c:strRef>
              <c:f>'275'!$S$105</c:f>
              <c:strCache>
                <c:ptCount val="1"/>
                <c:pt idx="0">
                  <c:v>Biomasa 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75'!$T$106:$T$112</c:f>
                <c:numCache>
                  <c:formatCode>General</c:formatCode>
                  <c:ptCount val="7"/>
                  <c:pt idx="0">
                    <c:v>1.6392605040078301E-3</c:v>
                  </c:pt>
                  <c:pt idx="1">
                    <c:v>1.0996616525095317E-2</c:v>
                  </c:pt>
                  <c:pt idx="2">
                    <c:v>0.17041122916345627</c:v>
                  </c:pt>
                  <c:pt idx="3">
                    <c:v>0.15463857862771488</c:v>
                  </c:pt>
                  <c:pt idx="4">
                    <c:v>7.6896033707857803E-2</c:v>
                  </c:pt>
                  <c:pt idx="5">
                    <c:v>3.2191778841809821E-2</c:v>
                  </c:pt>
                  <c:pt idx="6">
                    <c:v>0.18096085730068792</c:v>
                  </c:pt>
                </c:numCache>
              </c:numRef>
            </c:plus>
            <c:minus>
              <c:numRef>
                <c:f>'275'!$T$106:$T$112</c:f>
                <c:numCache>
                  <c:formatCode>General</c:formatCode>
                  <c:ptCount val="7"/>
                  <c:pt idx="0">
                    <c:v>1.6392605040078301E-3</c:v>
                  </c:pt>
                  <c:pt idx="1">
                    <c:v>1.0996616525095317E-2</c:v>
                  </c:pt>
                  <c:pt idx="2">
                    <c:v>0.17041122916345627</c:v>
                  </c:pt>
                  <c:pt idx="3">
                    <c:v>0.15463857862771488</c:v>
                  </c:pt>
                  <c:pt idx="4">
                    <c:v>7.6896033707857803E-2</c:v>
                  </c:pt>
                  <c:pt idx="5">
                    <c:v>3.2191778841809821E-2</c:v>
                  </c:pt>
                  <c:pt idx="6">
                    <c:v>0.18096085730068792</c:v>
                  </c:pt>
                </c:numCache>
              </c:numRef>
            </c:minus>
          </c:errBars>
          <c:xVal>
            <c:numRef>
              <c:f>'275'!$O$106:$O$11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0</c:v>
                </c:pt>
              </c:numCache>
            </c:numRef>
          </c:xVal>
          <c:yVal>
            <c:numRef>
              <c:f>'275'!$S$106:$S$112</c:f>
              <c:numCache>
                <c:formatCode>General</c:formatCode>
                <c:ptCount val="7"/>
                <c:pt idx="0">
                  <c:v>4.8465000000000001E-2</c:v>
                </c:pt>
                <c:pt idx="1">
                  <c:v>0.15580500000000005</c:v>
                </c:pt>
                <c:pt idx="2">
                  <c:v>0.61129500000000025</c:v>
                </c:pt>
                <c:pt idx="3">
                  <c:v>1.1438249999999994</c:v>
                </c:pt>
                <c:pt idx="4">
                  <c:v>1.394325</c:v>
                </c:pt>
                <c:pt idx="5">
                  <c:v>1.4373749999999996</c:v>
                </c:pt>
                <c:pt idx="6">
                  <c:v>1.294650000000000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275'!$Y$105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'275'!$AA$106:$AA$112</c:f>
                <c:numCache>
                  <c:formatCode>General</c:formatCode>
                  <c:ptCount val="7"/>
                  <c:pt idx="0">
                    <c:v>2.0984120980716187E-2</c:v>
                  </c:pt>
                  <c:pt idx="1">
                    <c:v>1.3796134724383262E-2</c:v>
                  </c:pt>
                  <c:pt idx="2">
                    <c:v>2.6274195198584739E-2</c:v>
                  </c:pt>
                  <c:pt idx="3">
                    <c:v>1.2741009902410913E-2</c:v>
                  </c:pt>
                  <c:pt idx="4">
                    <c:v>0.10729554200120976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75'!$AA$106:$AA$112</c:f>
                <c:numCache>
                  <c:formatCode>General</c:formatCode>
                  <c:ptCount val="7"/>
                  <c:pt idx="0">
                    <c:v>2.0984120980716187E-2</c:v>
                  </c:pt>
                  <c:pt idx="1">
                    <c:v>1.3796134724383262E-2</c:v>
                  </c:pt>
                  <c:pt idx="2">
                    <c:v>2.6274195198584739E-2</c:v>
                  </c:pt>
                  <c:pt idx="3">
                    <c:v>1.2741009902410913E-2</c:v>
                  </c:pt>
                  <c:pt idx="4">
                    <c:v>0.10729554200120976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75'!$V$106:$V$11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0</c:v>
                </c:pt>
              </c:numCache>
            </c:numRef>
          </c:xVal>
          <c:yVal>
            <c:numRef>
              <c:f>'275'!$Z$106:$Z$112</c:f>
              <c:numCache>
                <c:formatCode>General</c:formatCode>
                <c:ptCount val="7"/>
                <c:pt idx="0">
                  <c:v>3.6666666666666681E-2</c:v>
                </c:pt>
                <c:pt idx="1">
                  <c:v>0.12033333333333333</c:v>
                </c:pt>
                <c:pt idx="2">
                  <c:v>0.28266666666666684</c:v>
                </c:pt>
                <c:pt idx="3">
                  <c:v>0.39533333333333331</c:v>
                </c:pt>
                <c:pt idx="4">
                  <c:v>0.34366666666666673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1977728"/>
        <c:axId val="42000384"/>
      </c:scatterChart>
      <c:scatterChart>
        <c:scatterStyle val="smoothMarker"/>
        <c:ser>
          <c:idx val="1"/>
          <c:order val="1"/>
          <c:tx>
            <c:strRef>
              <c:f>'275'!$AF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75'!$AH$106:$AH$112</c:f>
                <c:numCache>
                  <c:formatCode>General</c:formatCode>
                  <c:ptCount val="7"/>
                  <c:pt idx="0">
                    <c:v>5.6580326380583378E-2</c:v>
                  </c:pt>
                  <c:pt idx="1">
                    <c:v>0.24289092202056456</c:v>
                  </c:pt>
                  <c:pt idx="2">
                    <c:v>0.39411292797877123</c:v>
                  </c:pt>
                  <c:pt idx="3">
                    <c:v>7.6376261582597402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75'!$AH$106:$AH$112</c:f>
                <c:numCache>
                  <c:formatCode>General</c:formatCode>
                  <c:ptCount val="7"/>
                  <c:pt idx="0">
                    <c:v>5.6580326380583378E-2</c:v>
                  </c:pt>
                  <c:pt idx="1">
                    <c:v>0.24289092202056456</c:v>
                  </c:pt>
                  <c:pt idx="2">
                    <c:v>0.39411292797877123</c:v>
                  </c:pt>
                  <c:pt idx="3">
                    <c:v>7.6376261582597402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75'!$AC$106:$AC$11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0</c:v>
                </c:pt>
              </c:numCache>
            </c:numRef>
          </c:xVal>
          <c:yVal>
            <c:numRef>
              <c:f>'275'!$AG$106:$AG$112</c:f>
              <c:numCache>
                <c:formatCode>General</c:formatCode>
                <c:ptCount val="7"/>
                <c:pt idx="0">
                  <c:v>2.3486666666666665</c:v>
                </c:pt>
                <c:pt idx="1">
                  <c:v>2.0409999999999999</c:v>
                </c:pt>
                <c:pt idx="2">
                  <c:v>1.244</c:v>
                </c:pt>
                <c:pt idx="3">
                  <c:v>0.2833333333333332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51405184"/>
        <c:axId val="42002688"/>
      </c:scatterChart>
      <c:valAx>
        <c:axId val="41977728"/>
        <c:scaling>
          <c:orientation val="minMax"/>
          <c:max val="1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000384"/>
        <c:crosses val="autoZero"/>
        <c:crossBetween val="midCat"/>
      </c:valAx>
      <c:valAx>
        <c:axId val="42000384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, Acetate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977728"/>
        <c:crosses val="autoZero"/>
        <c:crossBetween val="midCat"/>
      </c:valAx>
      <c:valAx>
        <c:axId val="42002688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91198732479430222"/>
              <c:y val="0.25788418310003086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51405184"/>
        <c:crosses val="max"/>
        <c:crossBetween val="midCat"/>
      </c:valAx>
      <c:valAx>
        <c:axId val="51405184"/>
        <c:scaling>
          <c:orientation val="minMax"/>
        </c:scaling>
        <c:delete val="1"/>
        <c:axPos val="b"/>
        <c:numFmt formatCode="General" sourceLinked="1"/>
        <c:tickLblPos val="none"/>
        <c:crossAx val="42002688"/>
        <c:crosses val="autoZero"/>
        <c:crossBetween val="midCat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76'!$S$105</c:f>
              <c:strCache>
                <c:ptCount val="1"/>
                <c:pt idx="0">
                  <c:v>Biomasa 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76'!$T$106:$T$112</c:f>
                <c:numCache>
                  <c:formatCode>General</c:formatCode>
                  <c:ptCount val="7"/>
                  <c:pt idx="0">
                    <c:v>1.6546298679765235E-3</c:v>
                  </c:pt>
                  <c:pt idx="1">
                    <c:v>3.5479082746035014E-2</c:v>
                  </c:pt>
                  <c:pt idx="2">
                    <c:v>6.3957808358323237E-2</c:v>
                  </c:pt>
                  <c:pt idx="3">
                    <c:v>2.2751160684677075E-2</c:v>
                  </c:pt>
                  <c:pt idx="4">
                    <c:v>1.5909902576697294E-2</c:v>
                  </c:pt>
                  <c:pt idx="5">
                    <c:v>0.29433319766890231</c:v>
                  </c:pt>
                  <c:pt idx="6">
                    <c:v>2.2114764581609242E-2</c:v>
                  </c:pt>
                </c:numCache>
              </c:numRef>
            </c:plus>
            <c:minus>
              <c:numRef>
                <c:f>'276'!$T$106:$T$112</c:f>
                <c:numCache>
                  <c:formatCode>General</c:formatCode>
                  <c:ptCount val="7"/>
                  <c:pt idx="0">
                    <c:v>1.6546298679765235E-3</c:v>
                  </c:pt>
                  <c:pt idx="1">
                    <c:v>3.5479082746035014E-2</c:v>
                  </c:pt>
                  <c:pt idx="2">
                    <c:v>6.3957808358323237E-2</c:v>
                  </c:pt>
                  <c:pt idx="3">
                    <c:v>2.2751160684677075E-2</c:v>
                  </c:pt>
                  <c:pt idx="4">
                    <c:v>1.5909902576697294E-2</c:v>
                  </c:pt>
                  <c:pt idx="5">
                    <c:v>0.29433319766890231</c:v>
                  </c:pt>
                  <c:pt idx="6">
                    <c:v>2.2114764581609242E-2</c:v>
                  </c:pt>
                </c:numCache>
              </c:numRef>
            </c:minus>
          </c:errBars>
          <c:xVal>
            <c:numRef>
              <c:f>'276'!$P$106:$P$11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12</c:v>
                </c:pt>
                <c:pt idx="6">
                  <c:v>14</c:v>
                </c:pt>
              </c:numCache>
            </c:numRef>
          </c:xVal>
          <c:yVal>
            <c:numRef>
              <c:f>'276'!$S$106:$S$112</c:f>
              <c:numCache>
                <c:formatCode>General</c:formatCode>
                <c:ptCount val="7"/>
                <c:pt idx="0">
                  <c:v>4.6710000000000015E-2</c:v>
                </c:pt>
                <c:pt idx="1">
                  <c:v>0.36956250000000013</c:v>
                </c:pt>
                <c:pt idx="2">
                  <c:v>1.0136249999999996</c:v>
                </c:pt>
                <c:pt idx="3">
                  <c:v>1.4221124999999999</c:v>
                </c:pt>
                <c:pt idx="4">
                  <c:v>1.361475</c:v>
                </c:pt>
                <c:pt idx="5">
                  <c:v>1.3045499999999999</c:v>
                </c:pt>
                <c:pt idx="6">
                  <c:v>1.3244625000000001</c:v>
                </c:pt>
              </c:numCache>
            </c:numRef>
          </c:yVal>
          <c:smooth val="1"/>
        </c:ser>
        <c:axId val="39926784"/>
        <c:axId val="39928960"/>
      </c:scatterChart>
      <c:scatterChart>
        <c:scatterStyle val="smoothMarker"/>
        <c:ser>
          <c:idx val="1"/>
          <c:order val="1"/>
          <c:tx>
            <c:strRef>
              <c:f>'276'!$X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76'!$Z$106:$Z$112</c:f>
                <c:numCache>
                  <c:formatCode>General</c:formatCode>
                  <c:ptCount val="7"/>
                  <c:pt idx="0">
                    <c:v>0.20435385976291234</c:v>
                  </c:pt>
                  <c:pt idx="1">
                    <c:v>0.26445793616376806</c:v>
                  </c:pt>
                  <c:pt idx="2">
                    <c:v>1.4142135623730968E-3</c:v>
                  </c:pt>
                  <c:pt idx="3">
                    <c:v>3.5355339059327383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76'!$Z$106:$Z$112</c:f>
                <c:numCache>
                  <c:formatCode>General</c:formatCode>
                  <c:ptCount val="7"/>
                  <c:pt idx="0">
                    <c:v>0.20435385976291234</c:v>
                  </c:pt>
                  <c:pt idx="1">
                    <c:v>0.26445793616376806</c:v>
                  </c:pt>
                  <c:pt idx="2">
                    <c:v>1.4142135623730968E-3</c:v>
                  </c:pt>
                  <c:pt idx="3">
                    <c:v>3.5355339059327383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76'!$V$106:$V$112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12</c:v>
                </c:pt>
                <c:pt idx="6">
                  <c:v>14</c:v>
                </c:pt>
              </c:numCache>
            </c:numRef>
          </c:xVal>
          <c:yVal>
            <c:numRef>
              <c:f>'276'!$Y$106:$Y$112</c:f>
              <c:numCache>
                <c:formatCode>General</c:formatCode>
                <c:ptCount val="7"/>
                <c:pt idx="0">
                  <c:v>2.6334999999999997</c:v>
                </c:pt>
                <c:pt idx="1">
                  <c:v>1.837</c:v>
                </c:pt>
                <c:pt idx="2">
                  <c:v>0.9</c:v>
                </c:pt>
                <c:pt idx="3">
                  <c:v>7.5000000000000011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39933056"/>
        <c:axId val="39930880"/>
      </c:scatterChart>
      <c:valAx>
        <c:axId val="39926784"/>
        <c:scaling>
          <c:orientation val="minMax"/>
          <c:max val="14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9928960"/>
        <c:crosses val="autoZero"/>
        <c:crossBetween val="midCat"/>
        <c:majorUnit val="2"/>
      </c:valAx>
      <c:valAx>
        <c:axId val="39928960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9926784"/>
        <c:crosses val="autoZero"/>
        <c:crossBetween val="midCat"/>
      </c:valAx>
      <c:valAx>
        <c:axId val="39930880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9933056"/>
        <c:crosses val="max"/>
        <c:crossBetween val="midCat"/>
      </c:valAx>
      <c:valAx>
        <c:axId val="39933056"/>
        <c:scaling>
          <c:orientation val="minMax"/>
        </c:scaling>
        <c:delete val="1"/>
        <c:axPos val="b"/>
        <c:numFmt formatCode="General" sourceLinked="1"/>
        <c:tickLblPos val="none"/>
        <c:crossAx val="39930880"/>
        <c:crosses val="autoZero"/>
        <c:crossBetween val="midCat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95'!$T$105</c:f>
              <c:strCache>
                <c:ptCount val="1"/>
                <c:pt idx="0">
                  <c:v>Biomasa 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95'!$U$106:$U$111</c:f>
                <c:numCache>
                  <c:formatCode>General</c:formatCode>
                  <c:ptCount val="6"/>
                  <c:pt idx="0">
                    <c:v>2.8706096913373659E-3</c:v>
                  </c:pt>
                  <c:pt idx="1">
                    <c:v>1.8628695606509961E-2</c:v>
                  </c:pt>
                  <c:pt idx="2">
                    <c:v>0.14362020839120579</c:v>
                  </c:pt>
                  <c:pt idx="3">
                    <c:v>0.18532374431878171</c:v>
                  </c:pt>
                  <c:pt idx="4">
                    <c:v>6.0959776697425513E-2</c:v>
                  </c:pt>
                  <c:pt idx="5">
                    <c:v>0.12539069193923455</c:v>
                  </c:pt>
                </c:numCache>
              </c:numRef>
            </c:plus>
            <c:minus>
              <c:numRef>
                <c:f>'295'!$U$106:$U$111</c:f>
                <c:numCache>
                  <c:formatCode>General</c:formatCode>
                  <c:ptCount val="6"/>
                  <c:pt idx="0">
                    <c:v>2.8706096913373659E-3</c:v>
                  </c:pt>
                  <c:pt idx="1">
                    <c:v>1.8628695606509961E-2</c:v>
                  </c:pt>
                  <c:pt idx="2">
                    <c:v>0.14362020839120579</c:v>
                  </c:pt>
                  <c:pt idx="3">
                    <c:v>0.18532374431878171</c:v>
                  </c:pt>
                  <c:pt idx="4">
                    <c:v>6.0959776697425513E-2</c:v>
                  </c:pt>
                  <c:pt idx="5">
                    <c:v>0.12539069193923455</c:v>
                  </c:pt>
                </c:numCache>
              </c:numRef>
            </c:minus>
          </c:errBars>
          <c:xVal>
            <c:numRef>
              <c:f>'295'!$P$106:$P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4</c:v>
                </c:pt>
              </c:numCache>
            </c:numRef>
          </c:xVal>
          <c:yVal>
            <c:numRef>
              <c:f>'295'!$T$106:$T$111</c:f>
              <c:numCache>
                <c:formatCode>General</c:formatCode>
                <c:ptCount val="6"/>
                <c:pt idx="0">
                  <c:v>4.8930000000000001E-2</c:v>
                </c:pt>
                <c:pt idx="1">
                  <c:v>0.11695499999999998</c:v>
                </c:pt>
                <c:pt idx="2">
                  <c:v>0.39853166666666684</c:v>
                </c:pt>
                <c:pt idx="3">
                  <c:v>1.0339833333333333</c:v>
                </c:pt>
                <c:pt idx="4">
                  <c:v>1.1166</c:v>
                </c:pt>
                <c:pt idx="5">
                  <c:v>1.105575</c:v>
                </c:pt>
              </c:numCache>
            </c:numRef>
          </c:yVal>
          <c:smooth val="1"/>
        </c:ser>
        <c:axId val="39976320"/>
        <c:axId val="40117760"/>
      </c:scatterChart>
      <c:scatterChart>
        <c:scatterStyle val="smoothMarker"/>
        <c:ser>
          <c:idx val="1"/>
          <c:order val="1"/>
          <c:tx>
            <c:strRef>
              <c:f>'295'!$Z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95'!$AB$106:$AB$111</c:f>
                <c:numCache>
                  <c:formatCode>General</c:formatCode>
                  <c:ptCount val="6"/>
                  <c:pt idx="0">
                    <c:v>0.50416713498600907</c:v>
                  </c:pt>
                  <c:pt idx="1">
                    <c:v>0.44898812159492008</c:v>
                  </c:pt>
                  <c:pt idx="2">
                    <c:v>0.33619835415024357</c:v>
                  </c:pt>
                  <c:pt idx="3">
                    <c:v>0.5548441222541699</c:v>
                  </c:pt>
                  <c:pt idx="4">
                    <c:v>0.19918584287042093</c:v>
                  </c:pt>
                  <c:pt idx="5">
                    <c:v>0</c:v>
                  </c:pt>
                </c:numCache>
              </c:numRef>
            </c:plus>
            <c:minus>
              <c:numRef>
                <c:f>'295'!$AB$106:$AB$111</c:f>
                <c:numCache>
                  <c:formatCode>General</c:formatCode>
                  <c:ptCount val="6"/>
                  <c:pt idx="0">
                    <c:v>0.50416713498600907</c:v>
                  </c:pt>
                  <c:pt idx="1">
                    <c:v>0.44898812159492008</c:v>
                  </c:pt>
                  <c:pt idx="2">
                    <c:v>0.33619835415024357</c:v>
                  </c:pt>
                  <c:pt idx="3">
                    <c:v>0.5548441222541699</c:v>
                  </c:pt>
                  <c:pt idx="4">
                    <c:v>0.19918584287042093</c:v>
                  </c:pt>
                  <c:pt idx="5">
                    <c:v>0</c:v>
                  </c:pt>
                </c:numCache>
              </c:numRef>
            </c:minus>
          </c:errBars>
          <c:xVal>
            <c:numRef>
              <c:f>'295'!$W$106:$W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4</c:v>
                </c:pt>
              </c:numCache>
            </c:numRef>
          </c:xVal>
          <c:yVal>
            <c:numRef>
              <c:f>'295'!$AA$106:$AA$111</c:f>
              <c:numCache>
                <c:formatCode>General</c:formatCode>
                <c:ptCount val="6"/>
                <c:pt idx="0">
                  <c:v>2.4339999999999997</c:v>
                </c:pt>
                <c:pt idx="1">
                  <c:v>2.2793333333333332</c:v>
                </c:pt>
                <c:pt idx="2">
                  <c:v>1.6373333333333335</c:v>
                </c:pt>
                <c:pt idx="3">
                  <c:v>0.49800000000000016</c:v>
                </c:pt>
                <c:pt idx="4">
                  <c:v>0.11499999999999998</c:v>
                </c:pt>
                <c:pt idx="5">
                  <c:v>0</c:v>
                </c:pt>
              </c:numCache>
            </c:numRef>
          </c:yVal>
          <c:smooth val="1"/>
        </c:ser>
        <c:axId val="40121856"/>
        <c:axId val="40119680"/>
      </c:scatterChart>
      <c:valAx>
        <c:axId val="39976320"/>
        <c:scaling>
          <c:orientation val="minMax"/>
          <c:max val="14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117760"/>
        <c:crosses val="autoZero"/>
        <c:crossBetween val="midCat"/>
        <c:majorUnit val="2"/>
      </c:valAx>
      <c:valAx>
        <c:axId val="40117760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9976320"/>
        <c:crosses val="autoZero"/>
        <c:crossBetween val="midCat"/>
      </c:valAx>
      <c:valAx>
        <c:axId val="40119680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121856"/>
        <c:crosses val="max"/>
        <c:crossBetween val="midCat"/>
      </c:valAx>
      <c:valAx>
        <c:axId val="40121856"/>
        <c:scaling>
          <c:orientation val="minMax"/>
        </c:scaling>
        <c:delete val="1"/>
        <c:axPos val="b"/>
        <c:numFmt formatCode="General" sourceLinked="1"/>
        <c:tickLblPos val="none"/>
        <c:crossAx val="40119680"/>
        <c:crosses val="autoZero"/>
        <c:crossBetween val="midCat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79'!$T$105</c:f>
              <c:strCache>
                <c:ptCount val="1"/>
                <c:pt idx="0">
                  <c:v>Biomasa 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79'!$U$106:$U$113</c:f>
                <c:numCache>
                  <c:formatCode>General</c:formatCode>
                  <c:ptCount val="8"/>
                  <c:pt idx="0">
                    <c:v>1.3364318164425773E-3</c:v>
                  </c:pt>
                  <c:pt idx="1">
                    <c:v>2.0523774323939516E-2</c:v>
                  </c:pt>
                  <c:pt idx="2">
                    <c:v>9.2436533970611509E-2</c:v>
                  </c:pt>
                  <c:pt idx="3">
                    <c:v>9.8287842584930521E-2</c:v>
                  </c:pt>
                  <c:pt idx="4">
                    <c:v>0.24628529188727513</c:v>
                  </c:pt>
                  <c:pt idx="5">
                    <c:v>3.309259735953031E-2</c:v>
                  </c:pt>
                  <c:pt idx="6">
                    <c:v>0.17278154198293325</c:v>
                  </c:pt>
                  <c:pt idx="7">
                    <c:v>2.2114764581609242E-2</c:v>
                  </c:pt>
                </c:numCache>
              </c:numRef>
            </c:plus>
            <c:minus>
              <c:numRef>
                <c:f>'279'!$U$106:$U$113</c:f>
                <c:numCache>
                  <c:formatCode>General</c:formatCode>
                  <c:ptCount val="8"/>
                  <c:pt idx="0">
                    <c:v>1.3364318164425773E-3</c:v>
                  </c:pt>
                  <c:pt idx="1">
                    <c:v>2.0523774323939516E-2</c:v>
                  </c:pt>
                  <c:pt idx="2">
                    <c:v>9.2436533970611509E-2</c:v>
                  </c:pt>
                  <c:pt idx="3">
                    <c:v>9.8287842584930521E-2</c:v>
                  </c:pt>
                  <c:pt idx="4">
                    <c:v>0.24628529188727513</c:v>
                  </c:pt>
                  <c:pt idx="5">
                    <c:v>3.309259735953031E-2</c:v>
                  </c:pt>
                  <c:pt idx="6">
                    <c:v>0.17278154198293325</c:v>
                  </c:pt>
                  <c:pt idx="7">
                    <c:v>2.2114764581609242E-2</c:v>
                  </c:pt>
                </c:numCache>
              </c:numRef>
            </c:minus>
          </c:errBars>
          <c:xVal>
            <c:numRef>
              <c:f>'279'!$P$106:$P$113</c:f>
              <c:numCache>
                <c:formatCode>General</c:formatCode>
                <c:ptCount val="8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.5</c:v>
                </c:pt>
                <c:pt idx="4">
                  <c:v>9</c:v>
                </c:pt>
                <c:pt idx="5">
                  <c:v>10</c:v>
                </c:pt>
                <c:pt idx="6">
                  <c:v>12</c:v>
                </c:pt>
                <c:pt idx="7">
                  <c:v>18</c:v>
                </c:pt>
              </c:numCache>
            </c:numRef>
          </c:xVal>
          <c:yVal>
            <c:numRef>
              <c:f>'279'!$T$106:$T$113</c:f>
              <c:numCache>
                <c:formatCode>General</c:formatCode>
                <c:ptCount val="8"/>
                <c:pt idx="0">
                  <c:v>4.4685000000000002E-2</c:v>
                </c:pt>
                <c:pt idx="1">
                  <c:v>0.12327750000000004</c:v>
                </c:pt>
                <c:pt idx="2">
                  <c:v>0.29418750000000016</c:v>
                </c:pt>
                <c:pt idx="3">
                  <c:v>0.51049999999999973</c:v>
                </c:pt>
                <c:pt idx="4">
                  <c:v>0.94680000000000009</c:v>
                </c:pt>
                <c:pt idx="5">
                  <c:v>1.0212750000000002</c:v>
                </c:pt>
                <c:pt idx="6">
                  <c:v>0.96727500000000033</c:v>
                </c:pt>
                <c:pt idx="7">
                  <c:v>1.0366875000000004</c:v>
                </c:pt>
              </c:numCache>
            </c:numRef>
          </c:yVal>
          <c:smooth val="1"/>
        </c:ser>
        <c:axId val="40206336"/>
        <c:axId val="40208256"/>
      </c:scatterChart>
      <c:scatterChart>
        <c:scatterStyle val="smoothMarker"/>
        <c:ser>
          <c:idx val="1"/>
          <c:order val="1"/>
          <c:tx>
            <c:strRef>
              <c:f>'279'!$Y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79'!$AA$106:$AA$113</c:f>
                <c:numCache>
                  <c:formatCode>General</c:formatCode>
                  <c:ptCount val="8"/>
                  <c:pt idx="0">
                    <c:v>1.2020815280171401E-2</c:v>
                  </c:pt>
                  <c:pt idx="1">
                    <c:v>5.5154328932550761E-2</c:v>
                  </c:pt>
                  <c:pt idx="2">
                    <c:v>4.3840620433565833E-2</c:v>
                  </c:pt>
                  <c:pt idx="3">
                    <c:v>5.7275649276110306E-2</c:v>
                  </c:pt>
                  <c:pt idx="4">
                    <c:v>0.17960512242138316</c:v>
                  </c:pt>
                  <c:pt idx="5">
                    <c:v>4.9497474683058342E-3</c:v>
                  </c:pt>
                  <c:pt idx="6">
                    <c:v>7.0710678118654849E-4</c:v>
                  </c:pt>
                  <c:pt idx="7">
                    <c:v>3.5355339059327372E-3</c:v>
                  </c:pt>
                </c:numCache>
              </c:numRef>
            </c:plus>
            <c:minus>
              <c:numRef>
                <c:f>'279'!$AA$106:$AA$113</c:f>
                <c:numCache>
                  <c:formatCode>General</c:formatCode>
                  <c:ptCount val="8"/>
                  <c:pt idx="0">
                    <c:v>1.2020815280171401E-2</c:v>
                  </c:pt>
                  <c:pt idx="1">
                    <c:v>5.5154328932550761E-2</c:v>
                  </c:pt>
                  <c:pt idx="2">
                    <c:v>4.3840620433565833E-2</c:v>
                  </c:pt>
                  <c:pt idx="3">
                    <c:v>5.7275649276110306E-2</c:v>
                  </c:pt>
                  <c:pt idx="4">
                    <c:v>0.17960512242138316</c:v>
                  </c:pt>
                  <c:pt idx="5">
                    <c:v>4.9497474683058342E-3</c:v>
                  </c:pt>
                  <c:pt idx="6">
                    <c:v>7.0710678118654849E-4</c:v>
                  </c:pt>
                  <c:pt idx="7">
                    <c:v>3.5355339059327372E-3</c:v>
                  </c:pt>
                </c:numCache>
              </c:numRef>
            </c:minus>
          </c:errBars>
          <c:xVal>
            <c:numRef>
              <c:f>'279'!$W$106:$W$113</c:f>
              <c:numCache>
                <c:formatCode>General</c:formatCode>
                <c:ptCount val="8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.5</c:v>
                </c:pt>
                <c:pt idx="4">
                  <c:v>9</c:v>
                </c:pt>
                <c:pt idx="5">
                  <c:v>10</c:v>
                </c:pt>
                <c:pt idx="6">
                  <c:v>12</c:v>
                </c:pt>
                <c:pt idx="7">
                  <c:v>18</c:v>
                </c:pt>
              </c:numCache>
            </c:numRef>
          </c:xVal>
          <c:yVal>
            <c:numRef>
              <c:f>'279'!$Z$106:$Z$113</c:f>
              <c:numCache>
                <c:formatCode>General</c:formatCode>
                <c:ptCount val="8"/>
                <c:pt idx="0">
                  <c:v>1.9344999999999999</c:v>
                </c:pt>
                <c:pt idx="1">
                  <c:v>1.7919999999999994</c:v>
                </c:pt>
                <c:pt idx="2">
                  <c:v>1.399</c:v>
                </c:pt>
                <c:pt idx="3">
                  <c:v>1.0105</c:v>
                </c:pt>
                <c:pt idx="4">
                  <c:v>0.25600000000000001</c:v>
                </c:pt>
                <c:pt idx="5">
                  <c:v>5.2500000000000012E-2</c:v>
                </c:pt>
                <c:pt idx="6">
                  <c:v>5.2500000000000012E-2</c:v>
                </c:pt>
                <c:pt idx="7">
                  <c:v>5.1499999999999997E-2</c:v>
                </c:pt>
              </c:numCache>
            </c:numRef>
          </c:yVal>
          <c:smooth val="1"/>
        </c:ser>
        <c:axId val="40257408"/>
        <c:axId val="40255488"/>
      </c:scatterChart>
      <c:valAx>
        <c:axId val="40206336"/>
        <c:scaling>
          <c:orientation val="minMax"/>
          <c:max val="18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208256"/>
        <c:crosses val="autoZero"/>
        <c:crossBetween val="midCat"/>
        <c:majorUnit val="2"/>
      </c:valAx>
      <c:valAx>
        <c:axId val="40208256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206336"/>
        <c:crosses val="autoZero"/>
        <c:crossBetween val="midCat"/>
      </c:valAx>
      <c:valAx>
        <c:axId val="40255488"/>
        <c:scaling>
          <c:orientation val="minMax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257408"/>
        <c:crosses val="max"/>
        <c:crossBetween val="midCat"/>
      </c:valAx>
      <c:valAx>
        <c:axId val="40257408"/>
        <c:scaling>
          <c:orientation val="minMax"/>
        </c:scaling>
        <c:delete val="1"/>
        <c:axPos val="b"/>
        <c:numFmt formatCode="General" sourceLinked="1"/>
        <c:tickLblPos val="none"/>
        <c:crossAx val="40255488"/>
        <c:crosses val="autoZero"/>
        <c:crossBetween val="midCat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scatterChart>
        <c:scatterStyle val="smoothMarker"/>
        <c:ser>
          <c:idx val="0"/>
          <c:order val="0"/>
          <c:tx>
            <c:strRef>
              <c:f>'277'!$S$105</c:f>
              <c:strCache>
                <c:ptCount val="1"/>
                <c:pt idx="0">
                  <c:v>Biomasa 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77'!$T$106:$T$111</c:f>
                <c:numCache>
                  <c:formatCode>General</c:formatCode>
                  <c:ptCount val="6"/>
                  <c:pt idx="0">
                    <c:v>2.9592418792657024E-3</c:v>
                  </c:pt>
                  <c:pt idx="1">
                    <c:v>5.8866639533780105E-3</c:v>
                  </c:pt>
                  <c:pt idx="2">
                    <c:v>4.2447620074628489E-2</c:v>
                  </c:pt>
                  <c:pt idx="3">
                    <c:v>0.17946370106514609</c:v>
                  </c:pt>
                  <c:pt idx="4">
                    <c:v>8.400428560496169E-2</c:v>
                  </c:pt>
                  <c:pt idx="5">
                    <c:v>5.2661777528868192E-2</c:v>
                  </c:pt>
                </c:numCache>
              </c:numRef>
            </c:plus>
            <c:minus>
              <c:numRef>
                <c:f>'277'!$T$106:$T$111</c:f>
                <c:numCache>
                  <c:formatCode>General</c:formatCode>
                  <c:ptCount val="6"/>
                  <c:pt idx="0">
                    <c:v>2.9592418792657024E-3</c:v>
                  </c:pt>
                  <c:pt idx="1">
                    <c:v>5.8866639533780105E-3</c:v>
                  </c:pt>
                  <c:pt idx="2">
                    <c:v>4.2447620074628489E-2</c:v>
                  </c:pt>
                  <c:pt idx="3">
                    <c:v>0.17946370106514609</c:v>
                  </c:pt>
                  <c:pt idx="4">
                    <c:v>8.400428560496169E-2</c:v>
                  </c:pt>
                  <c:pt idx="5">
                    <c:v>5.2661777528868192E-2</c:v>
                  </c:pt>
                </c:numCache>
              </c:numRef>
            </c:minus>
          </c:errBars>
          <c:xVal>
            <c:numRef>
              <c:f>'277'!$P$106:$P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0</c:v>
                </c:pt>
                <c:pt idx="5">
                  <c:v>12</c:v>
                </c:pt>
              </c:numCache>
            </c:numRef>
          </c:xVal>
          <c:yVal>
            <c:numRef>
              <c:f>'277'!$S$106:$S$111</c:f>
              <c:numCache>
                <c:formatCode>General</c:formatCode>
                <c:ptCount val="6"/>
                <c:pt idx="0">
                  <c:v>4.3672499999999996E-2</c:v>
                </c:pt>
                <c:pt idx="1">
                  <c:v>9.5062500000000008E-2</c:v>
                </c:pt>
                <c:pt idx="2">
                  <c:v>0.288045</c:v>
                </c:pt>
                <c:pt idx="3">
                  <c:v>1.2035249999999997</c:v>
                </c:pt>
                <c:pt idx="4">
                  <c:v>1.2275999999999996</c:v>
                </c:pt>
                <c:pt idx="5">
                  <c:v>1.2364875000000006</c:v>
                </c:pt>
              </c:numCache>
            </c:numRef>
          </c:yVal>
          <c:smooth val="1"/>
        </c:ser>
        <c:axId val="40300928"/>
        <c:axId val="40302848"/>
      </c:scatterChart>
      <c:scatterChart>
        <c:scatterStyle val="smoothMarker"/>
        <c:ser>
          <c:idx val="1"/>
          <c:order val="1"/>
          <c:tx>
            <c:strRef>
              <c:f>'277'!$Z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77'!$AA$106:$AA$111</c:f>
                <c:numCache>
                  <c:formatCode>General</c:formatCode>
                  <c:ptCount val="6"/>
                  <c:pt idx="0">
                    <c:v>1.0606601717797993E-2</c:v>
                  </c:pt>
                  <c:pt idx="1">
                    <c:v>4.2426406871192909E-3</c:v>
                  </c:pt>
                  <c:pt idx="2">
                    <c:v>8.4852813742385819E-3</c:v>
                  </c:pt>
                  <c:pt idx="3">
                    <c:v>0.1301076477383248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'277'!$AA$106:$AA$111</c:f>
                <c:numCache>
                  <c:formatCode>General</c:formatCode>
                  <c:ptCount val="6"/>
                  <c:pt idx="0">
                    <c:v>1.0606601717797993E-2</c:v>
                  </c:pt>
                  <c:pt idx="1">
                    <c:v>4.2426406871192909E-3</c:v>
                  </c:pt>
                  <c:pt idx="2">
                    <c:v>8.4852813742385819E-3</c:v>
                  </c:pt>
                  <c:pt idx="3">
                    <c:v>0.1301076477383248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</c:errBars>
          <c:xVal>
            <c:numRef>
              <c:f>'277'!$W$106:$W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0</c:v>
                </c:pt>
                <c:pt idx="5">
                  <c:v>12</c:v>
                </c:pt>
              </c:numCache>
            </c:numRef>
          </c:xVal>
          <c:yVal>
            <c:numRef>
              <c:f>'277'!$Z$106:$Z$111</c:f>
              <c:numCache>
                <c:formatCode>General</c:formatCode>
                <c:ptCount val="6"/>
                <c:pt idx="0">
                  <c:v>2.0625</c:v>
                </c:pt>
                <c:pt idx="1">
                  <c:v>1.9350000000000001</c:v>
                </c:pt>
                <c:pt idx="2">
                  <c:v>1.6180000000000001</c:v>
                </c:pt>
                <c:pt idx="3">
                  <c:v>0.24500000000000005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</c:ser>
        <c:axId val="40306944"/>
        <c:axId val="40305024"/>
      </c:scatterChart>
      <c:valAx>
        <c:axId val="40300928"/>
        <c:scaling>
          <c:orientation val="minMax"/>
          <c:max val="12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4.6073692070390223E-3"/>
              <c:y val="0.6985510239548256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02848"/>
        <c:crosses val="autoZero"/>
        <c:crossBetween val="midCat"/>
      </c:valAx>
      <c:valAx>
        <c:axId val="40302848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00928"/>
        <c:crosses val="autoZero"/>
        <c:crossBetween val="midCat"/>
      </c:valAx>
      <c:valAx>
        <c:axId val="40305024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06944"/>
        <c:crosses val="max"/>
        <c:crossBetween val="midCat"/>
      </c:valAx>
      <c:valAx>
        <c:axId val="40306944"/>
        <c:scaling>
          <c:orientation val="minMax"/>
        </c:scaling>
        <c:delete val="1"/>
        <c:axPos val="b"/>
        <c:numFmt formatCode="General" sourceLinked="1"/>
        <c:tickLblPos val="none"/>
        <c:crossAx val="40305024"/>
        <c:crosses val="autoZero"/>
        <c:crossBetween val="midCat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97'!$S$105</c:f>
              <c:strCache>
                <c:ptCount val="1"/>
                <c:pt idx="0">
                  <c:v>promedio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97'!$T$106:$T$115</c:f>
                <c:numCache>
                  <c:formatCode>General</c:formatCode>
                  <c:ptCount val="10"/>
                  <c:pt idx="0">
                    <c:v>4.4229529163218569E-3</c:v>
                  </c:pt>
                  <c:pt idx="1">
                    <c:v>1.600536199215756E-2</c:v>
                  </c:pt>
                  <c:pt idx="2">
                    <c:v>0.10971468816890491</c:v>
                  </c:pt>
                  <c:pt idx="3">
                    <c:v>5.883128419472064E-2</c:v>
                  </c:pt>
                  <c:pt idx="4">
                    <c:v>0.14333054454651298</c:v>
                  </c:pt>
                  <c:pt idx="5">
                    <c:v>0.18253961556330858</c:v>
                  </c:pt>
                  <c:pt idx="6">
                    <c:v>0.18312297865778743</c:v>
                  </c:pt>
                  <c:pt idx="7">
                    <c:v>0.1060660171779821</c:v>
                  </c:pt>
                  <c:pt idx="8">
                    <c:v>5.1618795026618113E-2</c:v>
                  </c:pt>
                  <c:pt idx="9">
                    <c:v>0.21877883809911869</c:v>
                  </c:pt>
                </c:numCache>
              </c:numRef>
            </c:plus>
            <c:minus>
              <c:numRef>
                <c:f>'297'!$T$106:$T$115</c:f>
                <c:numCache>
                  <c:formatCode>General</c:formatCode>
                  <c:ptCount val="10"/>
                  <c:pt idx="0">
                    <c:v>4.4229529163218569E-3</c:v>
                  </c:pt>
                  <c:pt idx="1">
                    <c:v>1.600536199215756E-2</c:v>
                  </c:pt>
                  <c:pt idx="2">
                    <c:v>0.10971468816890491</c:v>
                  </c:pt>
                  <c:pt idx="3">
                    <c:v>5.883128419472064E-2</c:v>
                  </c:pt>
                  <c:pt idx="4">
                    <c:v>0.14333054454651298</c:v>
                  </c:pt>
                  <c:pt idx="5">
                    <c:v>0.18253961556330858</c:v>
                  </c:pt>
                  <c:pt idx="6">
                    <c:v>0.18312297865778743</c:v>
                  </c:pt>
                  <c:pt idx="7">
                    <c:v>0.1060660171779821</c:v>
                  </c:pt>
                  <c:pt idx="8">
                    <c:v>5.1618795026618113E-2</c:v>
                  </c:pt>
                  <c:pt idx="9">
                    <c:v>0.21877883809911869</c:v>
                  </c:pt>
                </c:numCache>
              </c:numRef>
            </c:minus>
          </c:errBars>
          <c:xVal>
            <c:numRef>
              <c:f>'297'!$P$106:$P$114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7</c:v>
                </c:pt>
                <c:pt idx="5">
                  <c:v>21</c:v>
                </c:pt>
                <c:pt idx="6">
                  <c:v>24</c:v>
                </c:pt>
                <c:pt idx="7">
                  <c:v>25</c:v>
                </c:pt>
                <c:pt idx="8">
                  <c:v>27</c:v>
                </c:pt>
              </c:numCache>
            </c:numRef>
          </c:xVal>
          <c:yVal>
            <c:numRef>
              <c:f>'297'!$S$106:$S$114</c:f>
              <c:numCache>
                <c:formatCode>General</c:formatCode>
                <c:ptCount val="9"/>
                <c:pt idx="0">
                  <c:v>4.9297500000000029E-2</c:v>
                </c:pt>
                <c:pt idx="1">
                  <c:v>8.9347500000000024E-2</c:v>
                </c:pt>
                <c:pt idx="2">
                  <c:v>0.21019500000000008</c:v>
                </c:pt>
                <c:pt idx="3">
                  <c:v>0.2626</c:v>
                </c:pt>
                <c:pt idx="4">
                  <c:v>0.65735000000000032</c:v>
                </c:pt>
                <c:pt idx="5">
                  <c:v>1.1160749999999999</c:v>
                </c:pt>
                <c:pt idx="6">
                  <c:v>1.1446875000000003</c:v>
                </c:pt>
                <c:pt idx="7">
                  <c:v>1.175</c:v>
                </c:pt>
                <c:pt idx="8">
                  <c:v>1.1865000000000001</c:v>
                </c:pt>
              </c:numCache>
            </c:numRef>
          </c:yVal>
          <c:smooth val="1"/>
        </c:ser>
        <c:axId val="40358656"/>
        <c:axId val="40360576"/>
      </c:scatterChart>
      <c:scatterChart>
        <c:scatterStyle val="smoothMarker"/>
        <c:ser>
          <c:idx val="1"/>
          <c:order val="1"/>
          <c:tx>
            <c:strRef>
              <c:f>'297'!$X$10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97'!$Z$106:$Z$115</c:f>
                <c:numCache>
                  <c:formatCode>General</c:formatCode>
                  <c:ptCount val="10"/>
                  <c:pt idx="0">
                    <c:v>0.45466966030295025</c:v>
                  </c:pt>
                  <c:pt idx="1">
                    <c:v>0.48436814511278237</c:v>
                  </c:pt>
                  <c:pt idx="2">
                    <c:v>0.29274220741123064</c:v>
                  </c:pt>
                  <c:pt idx="3">
                    <c:v>0.1456639969244288</c:v>
                  </c:pt>
                  <c:pt idx="4">
                    <c:v>0.32031937187750553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'297'!$Z$106:$Z$115</c:f>
                <c:numCache>
                  <c:formatCode>General</c:formatCode>
                  <c:ptCount val="10"/>
                  <c:pt idx="0">
                    <c:v>0.45466966030295025</c:v>
                  </c:pt>
                  <c:pt idx="1">
                    <c:v>0.48436814511278237</c:v>
                  </c:pt>
                  <c:pt idx="2">
                    <c:v>0.29274220741123064</c:v>
                  </c:pt>
                  <c:pt idx="3">
                    <c:v>0.1456639969244288</c:v>
                  </c:pt>
                  <c:pt idx="4">
                    <c:v>0.32031937187750553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xVal>
            <c:numRef>
              <c:f>'297'!$V$106:$V$114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7</c:v>
                </c:pt>
                <c:pt idx="5">
                  <c:v>21</c:v>
                </c:pt>
                <c:pt idx="6">
                  <c:v>24</c:v>
                </c:pt>
                <c:pt idx="7">
                  <c:v>25</c:v>
                </c:pt>
                <c:pt idx="8">
                  <c:v>27</c:v>
                </c:pt>
              </c:numCache>
            </c:numRef>
          </c:xVal>
          <c:yVal>
            <c:numRef>
              <c:f>'297'!$Y$106:$Y$114</c:f>
              <c:numCache>
                <c:formatCode>General</c:formatCode>
                <c:ptCount val="9"/>
                <c:pt idx="0">
                  <c:v>2.450499999999999</c:v>
                </c:pt>
                <c:pt idx="1">
                  <c:v>2.3554999999999993</c:v>
                </c:pt>
                <c:pt idx="2">
                  <c:v>2.085</c:v>
                </c:pt>
                <c:pt idx="3">
                  <c:v>1.8129999999999995</c:v>
                </c:pt>
                <c:pt idx="4">
                  <c:v>1.190500000000000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yVal>
          <c:smooth val="1"/>
        </c:ser>
        <c:axId val="40364672"/>
        <c:axId val="40362752"/>
      </c:scatterChart>
      <c:valAx>
        <c:axId val="40358656"/>
        <c:scaling>
          <c:orientation val="minMax"/>
          <c:max val="24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60576"/>
        <c:crosses val="autoZero"/>
        <c:crossBetween val="midCat"/>
        <c:majorUnit val="4"/>
      </c:valAx>
      <c:valAx>
        <c:axId val="40360576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58656"/>
        <c:crosses val="autoZero"/>
        <c:crossBetween val="midCat"/>
      </c:valAx>
      <c:valAx>
        <c:axId val="40362752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364672"/>
        <c:crosses val="max"/>
        <c:crossBetween val="midCat"/>
      </c:valAx>
      <c:valAx>
        <c:axId val="40364672"/>
        <c:scaling>
          <c:orientation val="minMax"/>
        </c:scaling>
        <c:delete val="1"/>
        <c:axPos val="b"/>
        <c:numFmt formatCode="General" sourceLinked="1"/>
        <c:tickLblPos val="none"/>
        <c:crossAx val="40362752"/>
        <c:crosses val="autoZero"/>
        <c:crossBetween val="midCat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es-ES"/>
          </a:p>
        </p:txBody>
      </p:sp>
      <p:sp>
        <p:nvSpPr>
          <p:cNvPr id="1433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448E28C8-7C76-4D2A-B62D-18DDAB3B8C52}" type="datetimeFigureOut">
              <a:rPr lang="es-ES"/>
              <a:pPr/>
              <a:t>23/04/2013</a:t>
            </a:fld>
            <a:endParaRPr lang="es-ES"/>
          </a:p>
        </p:txBody>
      </p:sp>
      <p:sp>
        <p:nvSpPr>
          <p:cNvPr id="14340" name="Rectangle 4"/>
          <p:cNvSpPr>
            <a:spLocks noRo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sp>
      <p:sp>
        <p:nvSpPr>
          <p:cNvPr id="1434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Click to edit Master text styles</a:t>
            </a:r>
          </a:p>
          <a:p>
            <a:pPr lvl="1"/>
            <a:r>
              <a:rPr lang="es-ES" smtClean="0"/>
              <a:t>Second level</a:t>
            </a:r>
          </a:p>
          <a:p>
            <a:pPr lvl="2"/>
            <a:r>
              <a:rPr lang="es-ES" smtClean="0"/>
              <a:t>Third level</a:t>
            </a:r>
          </a:p>
          <a:p>
            <a:pPr lvl="3"/>
            <a:r>
              <a:rPr lang="es-ES" smtClean="0"/>
              <a:t>Fourth level</a:t>
            </a:r>
          </a:p>
          <a:p>
            <a:pPr lvl="4"/>
            <a:r>
              <a:rPr lang="es-ES" smtClean="0"/>
              <a:t>Fifth level</a:t>
            </a:r>
          </a:p>
        </p:txBody>
      </p:sp>
      <p:sp>
        <p:nvSpPr>
          <p:cNvPr id="1434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es-ES"/>
          </a:p>
        </p:txBody>
      </p:sp>
      <p:sp>
        <p:nvSpPr>
          <p:cNvPr id="1434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21A8DB5E-DFD9-4EB8-B489-4C85C6FFF212}" type="slidenum">
              <a:rPr lang="es-ES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26C28E-4DD0-4702-AAB1-9AA25D733C7D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595666-D32F-402A-B7B0-E0734606FC47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2FFB67-80C0-479E-870C-27ABE0F37275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212E94-FA82-4668-B6AD-E84982F45723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5E853E-CC69-4349-BD90-B6E2B3169960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6F9D70-4B0B-4C88-88B8-90AD75CD404C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3DC215-5226-402E-B23B-7D6EBE8602B6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939F48-0B1A-4FE6-93D5-6C091CDB9467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A37E56-3C08-44A5-8100-13264F9443C7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7659FD-F8B9-423E-BAA6-39066CBBBDFB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0BA6B-A31E-4341-B18B-26CD274C5331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6D5C35-97E5-4CAA-B962-6705A1C8978A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C9A76F-C9E1-4A65-8375-F1C8EC086EA8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ACB6F0-507B-4415-9642-9CA0BBBF709B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7B3918-34D2-4A13-9103-9A2B5ED3755D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03ED52-A1F4-4C7B-BCCA-CDCE2EC8812C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3471E4-C967-4831-A01B-1253E1BBC450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85B720-034A-4CD3-A64F-784DE65F5365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6D221-3711-474C-B2B7-78854E96FDF0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138B54-F8FC-4110-9C4B-10EA91694650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MX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9C4893-2A03-4270-BA21-AB5FA58F5839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45B761-46CA-4A5D-9D76-D6E37E10E4D6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  <a:endParaRPr lang="es-MX" smtClean="0"/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 smtClean="0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FBA3FC-B60D-4058-A6FC-287DC9E48CC9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0E0AB6F-CC13-47CE-B705-3762B822AF87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/>
        </p:nvGraphicFramePr>
        <p:xfrm>
          <a:off x="0" y="-30163"/>
          <a:ext cx="9144000" cy="489902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48000"/>
                <a:gridCol w="3048000"/>
                <a:gridCol w="3048000"/>
              </a:tblGrid>
              <a:tr h="2449996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/>
                    </a:p>
                  </a:txBody>
                  <a:tcPr>
                    <a:noFill/>
                  </a:tcPr>
                </a:tc>
              </a:tr>
              <a:tr h="2449996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6 Gráfico"/>
          <p:cNvGraphicFramePr>
            <a:graphicFrameLocks/>
          </p:cNvGraphicFramePr>
          <p:nvPr/>
        </p:nvGraphicFramePr>
        <p:xfrm>
          <a:off x="0" y="0"/>
          <a:ext cx="3059832" cy="234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8 Gráfico"/>
          <p:cNvGraphicFramePr>
            <a:graphicFrameLocks/>
          </p:cNvGraphicFramePr>
          <p:nvPr/>
        </p:nvGraphicFramePr>
        <p:xfrm>
          <a:off x="3059832" y="-27384"/>
          <a:ext cx="3024336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1 Gráfico"/>
          <p:cNvGraphicFramePr>
            <a:graphicFrameLocks/>
          </p:cNvGraphicFramePr>
          <p:nvPr/>
        </p:nvGraphicFramePr>
        <p:xfrm>
          <a:off x="6084168" y="0"/>
          <a:ext cx="3059832" cy="2420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1 Gráfico"/>
          <p:cNvGraphicFramePr>
            <a:graphicFrameLocks/>
          </p:cNvGraphicFramePr>
          <p:nvPr/>
        </p:nvGraphicFramePr>
        <p:xfrm>
          <a:off x="0" y="2420888"/>
          <a:ext cx="3078088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7 Gráfico"/>
          <p:cNvGraphicFramePr>
            <a:graphicFrameLocks/>
          </p:cNvGraphicFramePr>
          <p:nvPr/>
        </p:nvGraphicFramePr>
        <p:xfrm>
          <a:off x="2987824" y="2420888"/>
          <a:ext cx="3096344" cy="23822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1 Gráfico"/>
          <p:cNvGraphicFramePr>
            <a:graphicFrameLocks/>
          </p:cNvGraphicFramePr>
          <p:nvPr/>
        </p:nvGraphicFramePr>
        <p:xfrm>
          <a:off x="6097910" y="2348880"/>
          <a:ext cx="3046090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3334" name="11 CuadroTexto"/>
          <p:cNvSpPr txBox="1">
            <a:spLocks noChangeArrowheads="1"/>
          </p:cNvSpPr>
          <p:nvPr/>
        </p:nvSpPr>
        <p:spPr bwMode="auto">
          <a:xfrm>
            <a:off x="2627313" y="1844675"/>
            <a:ext cx="2889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A</a:t>
            </a:r>
          </a:p>
        </p:txBody>
      </p:sp>
      <p:sp>
        <p:nvSpPr>
          <p:cNvPr id="13335" name="13 CuadroTexto"/>
          <p:cNvSpPr txBox="1">
            <a:spLocks noChangeArrowheads="1"/>
          </p:cNvSpPr>
          <p:nvPr/>
        </p:nvSpPr>
        <p:spPr bwMode="auto">
          <a:xfrm>
            <a:off x="5651500" y="1844675"/>
            <a:ext cx="2889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B</a:t>
            </a:r>
          </a:p>
        </p:txBody>
      </p:sp>
      <p:sp>
        <p:nvSpPr>
          <p:cNvPr id="13336" name="14 CuadroTexto"/>
          <p:cNvSpPr txBox="1">
            <a:spLocks noChangeArrowheads="1"/>
          </p:cNvSpPr>
          <p:nvPr/>
        </p:nvSpPr>
        <p:spPr bwMode="auto">
          <a:xfrm>
            <a:off x="8856663" y="1844675"/>
            <a:ext cx="2873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C</a:t>
            </a:r>
          </a:p>
        </p:txBody>
      </p:sp>
      <p:sp>
        <p:nvSpPr>
          <p:cNvPr id="13337" name="15 CuadroTexto"/>
          <p:cNvSpPr txBox="1">
            <a:spLocks noChangeArrowheads="1"/>
          </p:cNvSpPr>
          <p:nvPr/>
        </p:nvSpPr>
        <p:spPr bwMode="auto">
          <a:xfrm>
            <a:off x="2627313" y="4371975"/>
            <a:ext cx="2889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D</a:t>
            </a:r>
          </a:p>
        </p:txBody>
      </p:sp>
      <p:sp>
        <p:nvSpPr>
          <p:cNvPr id="13338" name="16 CuadroTexto"/>
          <p:cNvSpPr txBox="1">
            <a:spLocks noChangeArrowheads="1"/>
          </p:cNvSpPr>
          <p:nvPr/>
        </p:nvSpPr>
        <p:spPr bwMode="auto">
          <a:xfrm>
            <a:off x="5651500" y="4341813"/>
            <a:ext cx="2889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E</a:t>
            </a:r>
          </a:p>
        </p:txBody>
      </p:sp>
      <p:sp>
        <p:nvSpPr>
          <p:cNvPr id="13339" name="17 CuadroTexto"/>
          <p:cNvSpPr txBox="1">
            <a:spLocks noChangeArrowheads="1"/>
          </p:cNvSpPr>
          <p:nvPr/>
        </p:nvSpPr>
        <p:spPr bwMode="auto">
          <a:xfrm>
            <a:off x="8856663" y="4332288"/>
            <a:ext cx="2873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F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</TotalTime>
  <Words>6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fugre</dc:creator>
  <cp:lastModifiedBy>Guillermo Gosset</cp:lastModifiedBy>
  <cp:revision>13</cp:revision>
  <dcterms:created xsi:type="dcterms:W3CDTF">2013-04-21T21:05:18Z</dcterms:created>
  <dcterms:modified xsi:type="dcterms:W3CDTF">2013-04-23T15:08:49Z</dcterms:modified>
</cp:coreProperties>
</file>